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0820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9C2C7-0758-4C39-A06B-B85EAAEC8E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23AC65-D9FD-4871-8C14-D991B43C7C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3CBA7-FE4D-48BA-B5DD-4473DD13D9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16A01-9AC1-4DB1-9E8A-98F0617E12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5E650D-547B-4291-8464-C13CCE4AC1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84523-D924-4B34-ADB0-ED8139CF97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DF28D-0A1C-4B79-94CB-9B712EC430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498B6-3704-4A32-8842-E2298467A9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45FB06-B047-4F5C-95C7-7416F0BB5F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8EA01-5B4E-43AA-8AE0-BD79F5D620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F581F-2AD1-4FFE-80DC-8524330DF3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78865-20C8-4DE1-BE3A-C79DCC743D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ACFE9A-93B0-4B53-A3FC-263245C28DCA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0" y="8906040"/>
            <a:ext cx="228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 2S (Supplementary Data)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30"/>
          <p:cNvSpPr/>
          <p:nvPr/>
        </p:nvSpPr>
        <p:spPr>
          <a:xfrm>
            <a:off x="2874960" y="-47520"/>
            <a:ext cx="110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RCC-25-090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3" name="Group 21"/>
          <p:cNvGrpSpPr/>
          <p:nvPr/>
        </p:nvGrpSpPr>
        <p:grpSpPr>
          <a:xfrm>
            <a:off x="1224000" y="98280"/>
            <a:ext cx="4383000" cy="7813800"/>
            <a:chOff x="1224000" y="98280"/>
            <a:chExt cx="4383000" cy="7813800"/>
          </a:xfrm>
        </p:grpSpPr>
        <p:pic>
          <p:nvPicPr>
            <p:cNvPr id="44" name="Picture 4" descr="C:\Documents and Settings\ncmlwl\Desktop\9-7-08_Histo Pics\9-7-08_RCC to Lung_C,Rapamycin,BMS,Sorafenib,Sutent,Avastin&amp;MK-0646_VEGF\Control\P7090002.JPG"/>
            <p:cNvPicPr/>
            <p:nvPr/>
          </p:nvPicPr>
          <p:blipFill>
            <a:blip r:embed="rId1"/>
            <a:stretch/>
          </p:blipFill>
          <p:spPr>
            <a:xfrm>
              <a:off x="2107080" y="4903920"/>
              <a:ext cx="1722960" cy="14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6" descr="C:\Documents and Settings\ncmlwl\Desktop\9-7-08_Histo Pics\9-7-08_RCC to Lung_C,Rapamycin,BMS,Sorafenib,Sutent,Avastin&amp;MK-0646_VEGF\Sutent\P7090015.JPG"/>
            <p:cNvPicPr/>
            <p:nvPr/>
          </p:nvPicPr>
          <p:blipFill>
            <a:blip r:embed="rId2"/>
            <a:stretch/>
          </p:blipFill>
          <p:spPr>
            <a:xfrm>
              <a:off x="3873240" y="4903920"/>
              <a:ext cx="1722960" cy="148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9" descr="C:\Documents and Settings\ncmlwl\Desktop\7-7-08_RCC to Lung_Control,BMS,Rapamycin,Sorafenib,Sutent,Avastin&amp;IGF-1RAb_p-ERK1-2_10x&amp;20x Magnifications\20x Magnification\Control\P7060001.JPG"/>
            <p:cNvPicPr/>
            <p:nvPr/>
          </p:nvPicPr>
          <p:blipFill>
            <a:blip r:embed="rId3"/>
            <a:stretch/>
          </p:blipFill>
          <p:spPr>
            <a:xfrm>
              <a:off x="2107080" y="6428160"/>
              <a:ext cx="1722960" cy="1483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11" descr="C:\Documents and Settings\ncmlwl\Desktop\7-7-08_RCC to Lung_Control,BMS,Rapamycin,Sorafenib,Sutent,Avastin&amp;IGF-1RAb_p-ERK1-2_10x&amp;20x Magnifications\20x Magnification\Sutent\P7060022.JPG"/>
            <p:cNvPicPr/>
            <p:nvPr/>
          </p:nvPicPr>
          <p:blipFill>
            <a:blip r:embed="rId4"/>
            <a:stretch/>
          </p:blipFill>
          <p:spPr>
            <a:xfrm>
              <a:off x="3873240" y="6428160"/>
              <a:ext cx="1722960" cy="1483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11" descr="C:\Documents and Settings\ncmlwl\Desktop\10-9-08_RCC-07-0408_Vehicle,Rapamycin,Sorafenib&amp;Sutent_alpha-Smooth Muscle Actin\RAPA1.5\P9100011.JPG"/>
            <p:cNvPicPr/>
            <p:nvPr/>
          </p:nvPicPr>
          <p:blipFill>
            <a:blip r:embed="rId5"/>
            <a:stretch/>
          </p:blipFill>
          <p:spPr>
            <a:xfrm>
              <a:off x="2111040" y="290880"/>
              <a:ext cx="1724400" cy="148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12" descr="C:\Documents and Settings\ncmlwl\Desktop\10-9-08_RCC-07-0408_Vehicle,Rapamycin,Sorafenib&amp;Sutent_alpha-Smooth Muscle Actin\RAPA + Soraf\P9100020.JPG"/>
            <p:cNvPicPr/>
            <p:nvPr/>
          </p:nvPicPr>
          <p:blipFill>
            <a:blip r:embed="rId6"/>
            <a:stretch/>
          </p:blipFill>
          <p:spPr>
            <a:xfrm>
              <a:off x="3882600" y="290880"/>
              <a:ext cx="1724400" cy="148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8" descr="C:\Documents and Settings\ncmlwl\Desktop\4-7-08_Histo Pic\4-7-08_RRC to Lung 07-0408_Control,Sorafenib,BMS,Sutent,Rapamycin,Avastin,&amp;IGF-1R_Ki-67\Sutent\P7040044.JPG"/>
            <p:cNvPicPr/>
            <p:nvPr/>
          </p:nvPicPr>
          <p:blipFill>
            <a:blip r:embed="rId7"/>
            <a:stretch/>
          </p:blipFill>
          <p:spPr>
            <a:xfrm>
              <a:off x="3878640" y="1832040"/>
              <a:ext cx="1726200" cy="148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9" descr="C:\Documents and Settings\ncmlwl\Desktop\4-7-08_Histo Pic\4-7-08_RRC to Lung 07-0408_Control,Sorafenib,BMS,Sutent,Rapamycin,Avastin,&amp;IGF-1R_Ki-67\Control\P7040036.JPG"/>
            <p:cNvPicPr/>
            <p:nvPr/>
          </p:nvPicPr>
          <p:blipFill>
            <a:blip r:embed="rId8"/>
            <a:stretch/>
          </p:blipFill>
          <p:spPr>
            <a:xfrm>
              <a:off x="2111040" y="1832040"/>
              <a:ext cx="1726200" cy="148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22" descr="C:\Documents and Settings\ncmlwl\Desktop\4-7-08_Histo Pic\4-7-08_RRC to Lung 07-0408_Control,Sorafenib,BMS,Sutent,Rapamycin,Avastin,&amp;IGF-1R_Cleaved PARP\Control\P7040003.JPG"/>
            <p:cNvPicPr/>
            <p:nvPr/>
          </p:nvPicPr>
          <p:blipFill>
            <a:blip r:embed="rId9"/>
            <a:stretch/>
          </p:blipFill>
          <p:spPr>
            <a:xfrm>
              <a:off x="2111040" y="3366360"/>
              <a:ext cx="1729080" cy="148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24" descr="C:\Documents and Settings\ncmlwl\Desktop\4-7-08_Histo Pic\4-7-08_RRC to Lung 07-0408_Control,Sorafenib,BMS,Sutent,Rapamycin,Avastin,&amp;IGF-1R_Cleaved PARP\Sutent20\P7040021.JPG"/>
            <p:cNvPicPr/>
            <p:nvPr/>
          </p:nvPicPr>
          <p:blipFill>
            <a:blip r:embed="rId10"/>
            <a:stretch/>
          </p:blipFill>
          <p:spPr>
            <a:xfrm>
              <a:off x="3879720" y="3366360"/>
              <a:ext cx="1716480" cy="1485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 Box 29"/>
            <p:cNvSpPr/>
            <p:nvPr/>
          </p:nvSpPr>
          <p:spPr>
            <a:xfrm>
              <a:off x="1415160" y="898200"/>
              <a:ext cx="61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D3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Text Box 31"/>
            <p:cNvSpPr/>
            <p:nvPr/>
          </p:nvSpPr>
          <p:spPr>
            <a:xfrm>
              <a:off x="1425960" y="2437920"/>
              <a:ext cx="61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Ki-67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Text Box 33"/>
            <p:cNvSpPr/>
            <p:nvPr/>
          </p:nvSpPr>
          <p:spPr>
            <a:xfrm>
              <a:off x="1224000" y="3927600"/>
              <a:ext cx="946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leaved PARP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Text Box 19"/>
            <p:cNvSpPr/>
            <p:nvPr/>
          </p:nvSpPr>
          <p:spPr>
            <a:xfrm>
              <a:off x="1456920" y="5527080"/>
              <a:ext cx="662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VEGF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Text Box 23"/>
            <p:cNvSpPr/>
            <p:nvPr/>
          </p:nvSpPr>
          <p:spPr>
            <a:xfrm>
              <a:off x="1361520" y="7108560"/>
              <a:ext cx="63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p-ERK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Text Box 30"/>
            <p:cNvSpPr/>
            <p:nvPr/>
          </p:nvSpPr>
          <p:spPr>
            <a:xfrm>
              <a:off x="2602080" y="98280"/>
              <a:ext cx="71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Vehicl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 Box 30"/>
            <p:cNvSpPr/>
            <p:nvPr/>
          </p:nvSpPr>
          <p:spPr>
            <a:xfrm>
              <a:off x="4411800" y="98280"/>
              <a:ext cx="83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Sorafenib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1" name="Rectangle 21"/>
          <p:cNvSpPr/>
          <p:nvPr/>
        </p:nvSpPr>
        <p:spPr>
          <a:xfrm>
            <a:off x="0" y="7873920"/>
            <a:ext cx="685800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Figure 2S. Effects of sorafenib on phospho-ERK1/2, VEGF expression, angiogenesis, cell proliferation and apoptosis of RCC-25-0908 xenograft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Mice bearing RCC-25-0908 tumors were randomized (10 mice/group) and treated with vehicle or 40 mg/kg/day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sorafenib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for 21 days. Representative pictures of blood vessels stained with anti-CD31, proliferative cells stained with anti-Ki-67, apoptotic cells stained with anti-cleaved-PARP, VEGF expression stained with anti-VEGF, and p-ERK1/2 stained with anti-phospho-ERK antibodies in vehicle- and drug-treated tumors are shown (200 </a:t>
            </a:r>
            <a:r>
              <a:rPr b="0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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). Experiments were repeated twice with similar results.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0T03:11:07Z</dcterms:created>
  <dc:creator>ncmlwl</dc:creator>
  <dc:description/>
  <dc:language>en-US</dc:language>
  <cp:lastModifiedBy>Lenovo User</cp:lastModifiedBy>
  <dcterms:modified xsi:type="dcterms:W3CDTF">2010-06-07T03:08:22Z</dcterms:modified>
  <cp:revision>14</cp:revision>
  <dc:subject/>
  <dc:title>PowerPoint Presentation</dc:title>
</cp:coreProperties>
</file>